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762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20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91339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5319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578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5652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307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0522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7466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8959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3327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10883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5698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16FA36-E484-46FB-A789-01315B660FFA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274EDB-8491-49D0-826D-79878C825B6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4449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TextBox 22">
            <a:extLst>
              <a:ext uri="{FF2B5EF4-FFF2-40B4-BE49-F238E27FC236}">
                <a16:creationId xmlns:a16="http://schemas.microsoft.com/office/drawing/2014/main" id="{CCFDFA84-E0B1-47C6-BD4D-4B9E9C76AB39}"/>
              </a:ext>
            </a:extLst>
          </p:cNvPr>
          <p:cNvSpPr txBox="1"/>
          <p:nvPr/>
        </p:nvSpPr>
        <p:spPr>
          <a:xfrm>
            <a:off x="742351" y="5821912"/>
            <a:ext cx="8023558" cy="11233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1.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-PCRs for the ribosomal proteins in the experimental models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PCR showing the expression of the top seven ribosomal proteins whose 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content in 3’UTR is upregulated upon 168 hours of transdifferentiation, in BLaER1 wildtype cells (BLaER1, 0 and 168 hours of transdifferentiation) and in pLKO.1-TRC empty vector BLaER1 (EV) and shRNA-METTL3 BLaER1 (sh2.1) cells (only at 168 hours of transdifferentiation).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T-Student test (P-Valu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ignificanc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: * &lt; 0.05, ** &lt; 0.001, *** &lt; 0.0001)</a:t>
            </a:r>
            <a:endParaRPr lang="es-E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4447" y="191999"/>
            <a:ext cx="1752519" cy="18000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1538" y="2006490"/>
            <a:ext cx="1752404" cy="1800000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91513" y="2006490"/>
            <a:ext cx="2050915" cy="1811424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06940" y="2006490"/>
            <a:ext cx="1765133" cy="1800000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81538" y="3905800"/>
            <a:ext cx="1787019" cy="1800000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81643" y="3905800"/>
            <a:ext cx="2102926" cy="1800000"/>
          </a:xfrm>
          <a:prstGeom prst="rect">
            <a:avLst/>
          </a:prstGeom>
        </p:spPr>
      </p:pic>
      <p:pic>
        <p:nvPicPr>
          <p:cNvPr id="15" name="Imagen 1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06940" y="3905800"/>
            <a:ext cx="2059024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2511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20</TotalTime>
  <Words>94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21</cp:revision>
  <dcterms:created xsi:type="dcterms:W3CDTF">2022-03-31T18:50:10Z</dcterms:created>
  <dcterms:modified xsi:type="dcterms:W3CDTF">2022-04-05T18:02:44Z</dcterms:modified>
</cp:coreProperties>
</file>